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  <p:sldId id="260" r:id="rId3"/>
    <p:sldId id="259" r:id="rId4"/>
    <p:sldId id="270" r:id="rId5"/>
    <p:sldId id="258" r:id="rId6"/>
    <p:sldId id="266" r:id="rId7"/>
    <p:sldId id="273" r:id="rId8"/>
    <p:sldId id="269" r:id="rId9"/>
    <p:sldId id="274" r:id="rId10"/>
  </p:sldIdLst>
  <p:sldSz cx="6858000" cy="9906000" type="A4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6E6E6"/>
    <a:srgbClr val="6B2BB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AB98484-75CC-45B6-B36B-6F89AD59AA95}" v="3" dt="2022-03-20T15:46:17.61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2634" y="-1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olni-marius nagalo" userId="4c7be995b936fd73" providerId="LiveId" clId="{07843B68-E7C9-4278-BE8E-1222F5FD689F}"/>
    <pc:docChg chg="delSld">
      <pc:chgData name="bolni-marius nagalo" userId="4c7be995b936fd73" providerId="LiveId" clId="{07843B68-E7C9-4278-BE8E-1222F5FD689F}" dt="2022-03-20T15:30:33.455" v="4" actId="47"/>
      <pc:docMkLst>
        <pc:docMk/>
      </pc:docMkLst>
      <pc:sldChg chg="del">
        <pc:chgData name="bolni-marius nagalo" userId="4c7be995b936fd73" providerId="LiveId" clId="{07843B68-E7C9-4278-BE8E-1222F5FD689F}" dt="2022-03-20T15:30:28.802" v="0" actId="47"/>
        <pc:sldMkLst>
          <pc:docMk/>
          <pc:sldMk cId="189316438" sldId="256"/>
        </pc:sldMkLst>
      </pc:sldChg>
      <pc:sldChg chg="del">
        <pc:chgData name="bolni-marius nagalo" userId="4c7be995b936fd73" providerId="LiveId" clId="{07843B68-E7C9-4278-BE8E-1222F5FD689F}" dt="2022-03-20T15:30:30.172" v="1" actId="47"/>
        <pc:sldMkLst>
          <pc:docMk/>
          <pc:sldMk cId="3716831596" sldId="257"/>
        </pc:sldMkLst>
      </pc:sldChg>
      <pc:sldChg chg="del">
        <pc:chgData name="bolni-marius nagalo" userId="4c7be995b936fd73" providerId="LiveId" clId="{07843B68-E7C9-4278-BE8E-1222F5FD689F}" dt="2022-03-20T15:30:31.641" v="2" actId="47"/>
        <pc:sldMkLst>
          <pc:docMk/>
          <pc:sldMk cId="3295939546" sldId="261"/>
        </pc:sldMkLst>
      </pc:sldChg>
      <pc:sldChg chg="del">
        <pc:chgData name="bolni-marius nagalo" userId="4c7be995b936fd73" providerId="LiveId" clId="{07843B68-E7C9-4278-BE8E-1222F5FD689F}" dt="2022-03-20T15:30:32.501" v="3" actId="47"/>
        <pc:sldMkLst>
          <pc:docMk/>
          <pc:sldMk cId="3522764758" sldId="262"/>
        </pc:sldMkLst>
      </pc:sldChg>
      <pc:sldChg chg="del">
        <pc:chgData name="bolni-marius nagalo" userId="4c7be995b936fd73" providerId="LiveId" clId="{07843B68-E7C9-4278-BE8E-1222F5FD689F}" dt="2022-03-20T15:30:33.455" v="4" actId="47"/>
        <pc:sldMkLst>
          <pc:docMk/>
          <pc:sldMk cId="4238062568" sldId="263"/>
        </pc:sldMkLst>
      </pc:sldChg>
    </pc:docChg>
  </pc:docChgLst>
  <pc:docChgLst>
    <pc:chgData name="bolni-marius nagalo" userId="4c7be995b936fd73" providerId="LiveId" clId="{4AB98484-75CC-45B6-B36B-6F89AD59AA95}"/>
    <pc:docChg chg="modSld">
      <pc:chgData name="bolni-marius nagalo" userId="4c7be995b936fd73" providerId="LiveId" clId="{4AB98484-75CC-45B6-B36B-6F89AD59AA95}" dt="2022-03-20T15:46:17.610" v="2" actId="20577"/>
      <pc:docMkLst>
        <pc:docMk/>
      </pc:docMkLst>
      <pc:sldChg chg="modSp mod">
        <pc:chgData name="bolni-marius nagalo" userId="4c7be995b936fd73" providerId="LiveId" clId="{4AB98484-75CC-45B6-B36B-6F89AD59AA95}" dt="2022-03-20T15:46:17.610" v="2" actId="20577"/>
        <pc:sldMkLst>
          <pc:docMk/>
          <pc:sldMk cId="4057215271" sldId="270"/>
        </pc:sldMkLst>
        <pc:spChg chg="mod">
          <ac:chgData name="bolni-marius nagalo" userId="4c7be995b936fd73" providerId="LiveId" clId="{4AB98484-75CC-45B6-B36B-6F89AD59AA95}" dt="2022-03-20T15:46:17.610" v="2" actId="20577"/>
          <ac:spMkLst>
            <pc:docMk/>
            <pc:sldMk cId="4057215271" sldId="270"/>
            <ac:spMk id="2" creationId="{01B30A50-12F7-4829-905A-E9EA541ABEF8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D8CFA-A5EF-4856-9691-0168395AACA0}" type="datetimeFigureOut">
              <a:rPr lang="en-US" smtClean="0"/>
              <a:t>11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8FE8A-50C4-4D8E-B137-929CBE4746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4418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D8CFA-A5EF-4856-9691-0168395AACA0}" type="datetimeFigureOut">
              <a:rPr lang="en-US" smtClean="0"/>
              <a:t>11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8FE8A-50C4-4D8E-B137-929CBE4746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8819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D8CFA-A5EF-4856-9691-0168395AACA0}" type="datetimeFigureOut">
              <a:rPr lang="en-US" smtClean="0"/>
              <a:t>11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8FE8A-50C4-4D8E-B137-929CBE4746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0345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D8CFA-A5EF-4856-9691-0168395AACA0}" type="datetimeFigureOut">
              <a:rPr lang="en-US" smtClean="0"/>
              <a:t>11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8FE8A-50C4-4D8E-B137-929CBE4746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0151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D8CFA-A5EF-4856-9691-0168395AACA0}" type="datetimeFigureOut">
              <a:rPr lang="en-US" smtClean="0"/>
              <a:t>11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8FE8A-50C4-4D8E-B137-929CBE4746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3260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D8CFA-A5EF-4856-9691-0168395AACA0}" type="datetimeFigureOut">
              <a:rPr lang="en-US" smtClean="0"/>
              <a:t>11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8FE8A-50C4-4D8E-B137-929CBE4746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0192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D8CFA-A5EF-4856-9691-0168395AACA0}" type="datetimeFigureOut">
              <a:rPr lang="en-US" smtClean="0"/>
              <a:t>11/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8FE8A-50C4-4D8E-B137-929CBE4746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63088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D8CFA-A5EF-4856-9691-0168395AACA0}" type="datetimeFigureOut">
              <a:rPr lang="en-US" smtClean="0"/>
              <a:t>11/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8FE8A-50C4-4D8E-B137-929CBE4746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166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D8CFA-A5EF-4856-9691-0168395AACA0}" type="datetimeFigureOut">
              <a:rPr lang="en-US" smtClean="0"/>
              <a:t>11/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8FE8A-50C4-4D8E-B137-929CBE4746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064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D8CFA-A5EF-4856-9691-0168395AACA0}" type="datetimeFigureOut">
              <a:rPr lang="en-US" smtClean="0"/>
              <a:t>11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8FE8A-50C4-4D8E-B137-929CBE4746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991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D8CFA-A5EF-4856-9691-0168395AACA0}" type="datetimeFigureOut">
              <a:rPr lang="en-US" smtClean="0"/>
              <a:t>11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18FE8A-50C4-4D8E-B137-929CBE4746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71465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3D8CFA-A5EF-4856-9691-0168395AACA0}" type="datetimeFigureOut">
              <a:rPr lang="en-US" smtClean="0"/>
              <a:t>11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18FE8A-50C4-4D8E-B137-929CBE4746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680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em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8C577EB-0523-4442-B46B-90A4001C34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7" y="3584930"/>
            <a:ext cx="5915025" cy="1914702"/>
          </a:xfrm>
        </p:spPr>
        <p:txBody>
          <a:bodyPr/>
          <a:lstStyle/>
          <a:p>
            <a:pPr algn="ctr"/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Supplementary data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5886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A9212C3F-D9C9-42E3-8439-B87AC9457924}"/>
              </a:ext>
            </a:extLst>
          </p:cNvPr>
          <p:cNvSpPr txBox="1"/>
          <p:nvPr/>
        </p:nvSpPr>
        <p:spPr>
          <a:xfrm>
            <a:off x="78063" y="186452"/>
            <a:ext cx="66712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Body weight and average tumor volume of mice treated with MMR vs. PBS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xmlns="" id="{6A564493-3C09-A723-6A36-63F9658AE373}"/>
              </a:ext>
            </a:extLst>
          </p:cNvPr>
          <p:cNvGrpSpPr/>
          <p:nvPr/>
        </p:nvGrpSpPr>
        <p:grpSpPr>
          <a:xfrm>
            <a:off x="78063" y="4538630"/>
            <a:ext cx="6858000" cy="5010534"/>
            <a:chOff x="0" y="1276708"/>
            <a:chExt cx="6858000" cy="5010534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xmlns="" id="{A20457BD-4017-A801-CFE7-95D5AEC0F74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1383557"/>
              <a:ext cx="6858000" cy="4903685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xmlns="" id="{BF0A1873-2E4B-41E3-8B3C-3325D9D3894F}"/>
                </a:ext>
              </a:extLst>
            </p:cNvPr>
            <p:cNvSpPr txBox="1"/>
            <p:nvPr/>
          </p:nvSpPr>
          <p:spPr>
            <a:xfrm>
              <a:off x="78063" y="1276709"/>
              <a:ext cx="2173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276B4433-018E-DAE0-6434-A8FF07E99906}"/>
                </a:ext>
              </a:extLst>
            </p:cNvPr>
            <p:cNvSpPr txBox="1"/>
            <p:nvPr/>
          </p:nvSpPr>
          <p:spPr>
            <a:xfrm>
              <a:off x="3503427" y="1276708"/>
              <a:ext cx="2173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xmlns="" id="{48CBC77E-5C3E-A579-72D8-7CC7DD9BB75A}"/>
                </a:ext>
              </a:extLst>
            </p:cNvPr>
            <p:cNvSpPr txBox="1"/>
            <p:nvPr/>
          </p:nvSpPr>
          <p:spPr>
            <a:xfrm>
              <a:off x="186723" y="3917435"/>
              <a:ext cx="2173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695D8A1B-7F4B-16B4-9A82-0687B5034A8B}"/>
                </a:ext>
              </a:extLst>
            </p:cNvPr>
            <p:cNvSpPr txBox="1"/>
            <p:nvPr/>
          </p:nvSpPr>
          <p:spPr>
            <a:xfrm>
              <a:off x="3545428" y="3917435"/>
              <a:ext cx="2173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3AC95CC2-37CD-3DFC-FA8A-F99D372894CD}"/>
              </a:ext>
            </a:extLst>
          </p:cNvPr>
          <p:cNvSpPr txBox="1"/>
          <p:nvPr/>
        </p:nvSpPr>
        <p:spPr>
          <a:xfrm>
            <a:off x="1166495" y="963222"/>
            <a:ext cx="291861" cy="434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xmlns="" id="{7E543455-3D95-045C-E063-F3CA8053F742}"/>
              </a:ext>
            </a:extLst>
          </p:cNvPr>
          <p:cNvGrpSpPr/>
          <p:nvPr/>
        </p:nvGrpSpPr>
        <p:grpSpPr>
          <a:xfrm>
            <a:off x="1275588" y="884595"/>
            <a:ext cx="4306824" cy="3468458"/>
            <a:chOff x="1092820" y="884595"/>
            <a:chExt cx="4306824" cy="3468458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58D4A0E6-D308-52D4-D400-A1EA5584066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92820" y="884595"/>
              <a:ext cx="4306824" cy="3397707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2347B1E9-2D26-438E-E11C-924D3BB8316F}"/>
                </a:ext>
              </a:extLst>
            </p:cNvPr>
            <p:cNvSpPr txBox="1"/>
            <p:nvPr/>
          </p:nvSpPr>
          <p:spPr>
            <a:xfrm>
              <a:off x="3429000" y="963222"/>
              <a:ext cx="291861" cy="4345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xmlns="" id="{4645C88F-F3DD-154D-B271-258398DC6D98}"/>
                </a:ext>
              </a:extLst>
            </p:cNvPr>
            <p:cNvSpPr txBox="1"/>
            <p:nvPr/>
          </p:nvSpPr>
          <p:spPr>
            <a:xfrm>
              <a:off x="3002197" y="3875050"/>
              <a:ext cx="1242588" cy="4780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solidFill>
                    <a:srgbClr val="0E101A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TCID</a:t>
              </a:r>
              <a:r>
                <a:rPr lang="en-US" sz="1600" baseline="-25000" dirty="0">
                  <a:solidFill>
                    <a:srgbClr val="0E101A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50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751835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A7980343-2411-4CEE-A38F-6DDCB2175F04}"/>
              </a:ext>
            </a:extLst>
          </p:cNvPr>
          <p:cNvSpPr txBox="1"/>
          <p:nvPr/>
        </p:nvSpPr>
        <p:spPr>
          <a:xfrm>
            <a:off x="148589" y="87587"/>
            <a:ext cx="65608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Analysis of markers of hepatotoxicity and nephrotoxicity following IT administrations of MMR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17812244-B278-3EC2-4D68-AA5CB2B617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8427" y="3999558"/>
            <a:ext cx="5631393" cy="171188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C13995A4-DE4E-E40F-B2C6-1CBEF411EB9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560128"/>
            <a:ext cx="6858000" cy="3390784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86182E77-0041-439B-A37B-E23362C34E98}"/>
              </a:ext>
            </a:extLst>
          </p:cNvPr>
          <p:cNvSpPr txBox="1"/>
          <p:nvPr/>
        </p:nvSpPr>
        <p:spPr>
          <a:xfrm>
            <a:off x="129230" y="480412"/>
            <a:ext cx="217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D3F9ACEA-EC6C-4353-B50F-A3D947FF16AF}"/>
              </a:ext>
            </a:extLst>
          </p:cNvPr>
          <p:cNvSpPr txBox="1"/>
          <p:nvPr/>
        </p:nvSpPr>
        <p:spPr>
          <a:xfrm>
            <a:off x="1794989" y="480412"/>
            <a:ext cx="217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E3E27110-8937-4FA0-AED9-124D04B09101}"/>
              </a:ext>
            </a:extLst>
          </p:cNvPr>
          <p:cNvSpPr txBox="1"/>
          <p:nvPr/>
        </p:nvSpPr>
        <p:spPr>
          <a:xfrm>
            <a:off x="3455105" y="493223"/>
            <a:ext cx="217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140D8DEF-30FB-4E6A-AAFD-7EEE8EFEE560}"/>
              </a:ext>
            </a:extLst>
          </p:cNvPr>
          <p:cNvSpPr txBox="1"/>
          <p:nvPr/>
        </p:nvSpPr>
        <p:spPr>
          <a:xfrm>
            <a:off x="5115221" y="483970"/>
            <a:ext cx="217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88F11218-9427-4EB0-9682-95CA76B65E27}"/>
              </a:ext>
            </a:extLst>
          </p:cNvPr>
          <p:cNvSpPr txBox="1"/>
          <p:nvPr/>
        </p:nvSpPr>
        <p:spPr>
          <a:xfrm>
            <a:off x="109817" y="2271424"/>
            <a:ext cx="217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CF10695D-3282-43F1-9B9F-E2002E52F7CE}"/>
              </a:ext>
            </a:extLst>
          </p:cNvPr>
          <p:cNvSpPr txBox="1"/>
          <p:nvPr/>
        </p:nvSpPr>
        <p:spPr>
          <a:xfrm>
            <a:off x="1868172" y="2271424"/>
            <a:ext cx="217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2E2200AB-7C84-455D-A2A5-1FE3BEEFB83E}"/>
              </a:ext>
            </a:extLst>
          </p:cNvPr>
          <p:cNvSpPr txBox="1"/>
          <p:nvPr/>
        </p:nvSpPr>
        <p:spPr>
          <a:xfrm>
            <a:off x="3431831" y="2269096"/>
            <a:ext cx="217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04A661E3-57F5-4D78-A8FA-FB3804439368}"/>
              </a:ext>
            </a:extLst>
          </p:cNvPr>
          <p:cNvSpPr txBox="1"/>
          <p:nvPr/>
        </p:nvSpPr>
        <p:spPr>
          <a:xfrm>
            <a:off x="5109016" y="2377717"/>
            <a:ext cx="217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43DFA0A3-CC8D-4F44-970E-9D07A2F403AD}"/>
              </a:ext>
            </a:extLst>
          </p:cNvPr>
          <p:cNvSpPr txBox="1"/>
          <p:nvPr/>
        </p:nvSpPr>
        <p:spPr>
          <a:xfrm>
            <a:off x="678180" y="3999558"/>
            <a:ext cx="217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9DEAF800-A467-48B3-BD30-D5F0C54DA7C7}"/>
              </a:ext>
            </a:extLst>
          </p:cNvPr>
          <p:cNvSpPr txBox="1"/>
          <p:nvPr/>
        </p:nvSpPr>
        <p:spPr>
          <a:xfrm>
            <a:off x="2587795" y="4006285"/>
            <a:ext cx="217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1870E426-63E7-4E0B-BE85-0A3D4C7753C1}"/>
              </a:ext>
            </a:extLst>
          </p:cNvPr>
          <p:cNvSpPr txBox="1"/>
          <p:nvPr/>
        </p:nvSpPr>
        <p:spPr>
          <a:xfrm>
            <a:off x="4383807" y="4008562"/>
            <a:ext cx="217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1612259E-C35C-1A84-073E-9B87A36332C1}"/>
              </a:ext>
            </a:extLst>
          </p:cNvPr>
          <p:cNvSpPr txBox="1"/>
          <p:nvPr/>
        </p:nvSpPr>
        <p:spPr>
          <a:xfrm>
            <a:off x="678180" y="6195420"/>
            <a:ext cx="571041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ormal mouse blood chemistry parameter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graphicFrame>
        <p:nvGraphicFramePr>
          <p:cNvPr id="28" name="Table 3">
            <a:extLst>
              <a:ext uri="{FF2B5EF4-FFF2-40B4-BE49-F238E27FC236}">
                <a16:creationId xmlns:a16="http://schemas.microsoft.com/office/drawing/2014/main" xmlns="" id="{D67F42DC-D0AD-1328-C15F-291EEB176D9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81834227"/>
              </p:ext>
            </p:extLst>
          </p:nvPr>
        </p:nvGraphicFramePr>
        <p:xfrm>
          <a:off x="95249" y="6621783"/>
          <a:ext cx="6667500" cy="10389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98057">
                  <a:extLst>
                    <a:ext uri="{9D8B030D-6E8A-4147-A177-3AD203B41FA5}">
                      <a16:colId xmlns:a16="http://schemas.microsoft.com/office/drawing/2014/main" xmlns="" val="2691146914"/>
                    </a:ext>
                  </a:extLst>
                </a:gridCol>
                <a:gridCol w="576765">
                  <a:extLst>
                    <a:ext uri="{9D8B030D-6E8A-4147-A177-3AD203B41FA5}">
                      <a16:colId xmlns:a16="http://schemas.microsoft.com/office/drawing/2014/main" xmlns="" val="2577470743"/>
                    </a:ext>
                  </a:extLst>
                </a:gridCol>
                <a:gridCol w="769020">
                  <a:extLst>
                    <a:ext uri="{9D8B030D-6E8A-4147-A177-3AD203B41FA5}">
                      <a16:colId xmlns:a16="http://schemas.microsoft.com/office/drawing/2014/main" xmlns="" val="3303894802"/>
                    </a:ext>
                  </a:extLst>
                </a:gridCol>
                <a:gridCol w="759407">
                  <a:extLst>
                    <a:ext uri="{9D8B030D-6E8A-4147-A177-3AD203B41FA5}">
                      <a16:colId xmlns:a16="http://schemas.microsoft.com/office/drawing/2014/main" xmlns="" val="2125819842"/>
                    </a:ext>
                  </a:extLst>
                </a:gridCol>
                <a:gridCol w="615216">
                  <a:extLst>
                    <a:ext uri="{9D8B030D-6E8A-4147-A177-3AD203B41FA5}">
                      <a16:colId xmlns:a16="http://schemas.microsoft.com/office/drawing/2014/main" xmlns="" val="3658496166"/>
                    </a:ext>
                  </a:extLst>
                </a:gridCol>
                <a:gridCol w="615093">
                  <a:extLst>
                    <a:ext uri="{9D8B030D-6E8A-4147-A177-3AD203B41FA5}">
                      <a16:colId xmlns:a16="http://schemas.microsoft.com/office/drawing/2014/main" xmlns="" val="1770282509"/>
                    </a:ext>
                  </a:extLst>
                </a:gridCol>
                <a:gridCol w="682629">
                  <a:extLst>
                    <a:ext uri="{9D8B030D-6E8A-4147-A177-3AD203B41FA5}">
                      <a16:colId xmlns:a16="http://schemas.microsoft.com/office/drawing/2014/main" xmlns="" val="854261982"/>
                    </a:ext>
                  </a:extLst>
                </a:gridCol>
                <a:gridCol w="615216">
                  <a:extLst>
                    <a:ext uri="{9D8B030D-6E8A-4147-A177-3AD203B41FA5}">
                      <a16:colId xmlns:a16="http://schemas.microsoft.com/office/drawing/2014/main" xmlns="" val="852085819"/>
                    </a:ext>
                  </a:extLst>
                </a:gridCol>
                <a:gridCol w="645522">
                  <a:extLst>
                    <a:ext uri="{9D8B030D-6E8A-4147-A177-3AD203B41FA5}">
                      <a16:colId xmlns:a16="http://schemas.microsoft.com/office/drawing/2014/main" xmlns="" val="733350373"/>
                    </a:ext>
                  </a:extLst>
                </a:gridCol>
                <a:gridCol w="790575">
                  <a:extLst>
                    <a:ext uri="{9D8B030D-6E8A-4147-A177-3AD203B41FA5}">
                      <a16:colId xmlns:a16="http://schemas.microsoft.com/office/drawing/2014/main" xmlns="" val="3094677988"/>
                    </a:ext>
                  </a:extLst>
                </a:gridCol>
              </a:tblGrid>
              <a:tr h="553645"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T</a:t>
                      </a:r>
                    </a:p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U/L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P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U/L)</a:t>
                      </a:r>
                    </a:p>
                    <a:p>
                      <a:pPr algn="ctr"/>
                      <a:endParaRPr lang="en-US" sz="12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N</a:t>
                      </a:r>
                    </a:p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g/dL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BIL</a:t>
                      </a:r>
                    </a:p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g/dL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B</a:t>
                      </a:r>
                    </a:p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g/dL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Y</a:t>
                      </a:r>
                    </a:p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U/L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E</a:t>
                      </a:r>
                    </a:p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g/</a:t>
                      </a:r>
                      <a:r>
                        <a:rPr lang="en-US" sz="1200" b="1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</a:t>
                      </a:r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</a:t>
                      </a:r>
                    </a:p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g/dL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OB</a:t>
                      </a:r>
                    </a:p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g/dL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U</a:t>
                      </a:r>
                    </a:p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g/</a:t>
                      </a:r>
                      <a:r>
                        <a:rPr lang="en-US" sz="1200" b="1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</a:t>
                      </a:r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996976590"/>
                  </a:ext>
                </a:extLst>
              </a:tr>
              <a:tr h="398855"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5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10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-45.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100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1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5.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1.0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40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4117503263"/>
                  </a:ext>
                </a:extLst>
              </a:tr>
            </a:tbl>
          </a:graphicData>
        </a:graphic>
      </p:graphicFrame>
      <p:graphicFrame>
        <p:nvGraphicFramePr>
          <p:cNvPr id="29" name="Table 28">
            <a:extLst>
              <a:ext uri="{FF2B5EF4-FFF2-40B4-BE49-F238E27FC236}">
                <a16:creationId xmlns:a16="http://schemas.microsoft.com/office/drawing/2014/main" xmlns="" id="{E5DBC27F-6062-DF52-A01E-1E92FD3BB5A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13181562"/>
              </p:ext>
            </p:extLst>
          </p:nvPr>
        </p:nvGraphicFramePr>
        <p:xfrm>
          <a:off x="1468572" y="8631627"/>
          <a:ext cx="3879931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98057">
                  <a:extLst>
                    <a:ext uri="{9D8B030D-6E8A-4147-A177-3AD203B41FA5}">
                      <a16:colId xmlns:a16="http://schemas.microsoft.com/office/drawing/2014/main" xmlns="" val="2691146914"/>
                    </a:ext>
                  </a:extLst>
                </a:gridCol>
                <a:gridCol w="770530">
                  <a:extLst>
                    <a:ext uri="{9D8B030D-6E8A-4147-A177-3AD203B41FA5}">
                      <a16:colId xmlns:a16="http://schemas.microsoft.com/office/drawing/2014/main" xmlns="" val="2577470743"/>
                    </a:ext>
                  </a:extLst>
                </a:gridCol>
                <a:gridCol w="815894">
                  <a:extLst>
                    <a:ext uri="{9D8B030D-6E8A-4147-A177-3AD203B41FA5}">
                      <a16:colId xmlns:a16="http://schemas.microsoft.com/office/drawing/2014/main" xmlns="" val="3303894802"/>
                    </a:ext>
                  </a:extLst>
                </a:gridCol>
                <a:gridCol w="866775">
                  <a:extLst>
                    <a:ext uri="{9D8B030D-6E8A-4147-A177-3AD203B41FA5}">
                      <a16:colId xmlns:a16="http://schemas.microsoft.com/office/drawing/2014/main" xmlns="" val="2125819842"/>
                    </a:ext>
                  </a:extLst>
                </a:gridCol>
                <a:gridCol w="828675">
                  <a:extLst>
                    <a:ext uri="{9D8B030D-6E8A-4147-A177-3AD203B41FA5}">
                      <a16:colId xmlns:a16="http://schemas.microsoft.com/office/drawing/2014/main" xmlns="" val="3658496166"/>
                    </a:ext>
                  </a:extLst>
                </a:gridCol>
              </a:tblGrid>
              <a:tr h="452647"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M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</a:t>
                      </a:r>
                    </a:p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g/</a:t>
                      </a:r>
                      <a:r>
                        <a:rPr lang="en-US" sz="1200" b="1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</a:t>
                      </a:r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OS</a:t>
                      </a:r>
                    </a:p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g/</a:t>
                      </a:r>
                      <a:r>
                        <a:rPr lang="en-US" sz="1200" b="1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</a:t>
                      </a:r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+</a:t>
                      </a:r>
                    </a:p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mol/L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+</a:t>
                      </a:r>
                    </a:p>
                    <a:p>
                      <a:pPr algn="ctr"/>
                      <a:r>
                        <a:rPr lang="en-US" sz="12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mol/L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996976590"/>
                  </a:ext>
                </a:extLst>
              </a:tr>
              <a:tr h="133350"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11.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15.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16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4117503263"/>
                  </a:ext>
                </a:extLst>
              </a:tr>
            </a:tbl>
          </a:graphicData>
        </a:graphic>
      </p:graphicFrame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F25AA20F-999D-05FC-2173-472F33D3D4A3}"/>
              </a:ext>
            </a:extLst>
          </p:cNvPr>
          <p:cNvSpPr txBox="1"/>
          <p:nvPr/>
        </p:nvSpPr>
        <p:spPr>
          <a:xfrm>
            <a:off x="199513" y="7749948"/>
            <a:ext cx="6458971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lanine aminotransferase (ALT), Alkaline Phosphatase (ALP), Blood Urea Nitrogen (BUN), Total Bilirubin (TBIL), Serum Albumin (ALB), Amylase (AMY), Creatinine (CRE), Total Protein (TP), Globulin (GLO), Glutamine (GLU)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FA9AD95F-460D-984E-5EC0-096BAF562E59}"/>
              </a:ext>
            </a:extLst>
          </p:cNvPr>
          <p:cNvSpPr txBox="1"/>
          <p:nvPr/>
        </p:nvSpPr>
        <p:spPr>
          <a:xfrm>
            <a:off x="594015" y="10182225"/>
            <a:ext cx="60644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em protein (HEM), Calcium (CA), Phosphate (PHOS), Sodium (NA+), Potassium (K+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FF2D74EF-D296-F6EE-FCE7-E6657A2EA988}"/>
              </a:ext>
            </a:extLst>
          </p:cNvPr>
          <p:cNvSpPr txBox="1"/>
          <p:nvPr/>
        </p:nvSpPr>
        <p:spPr>
          <a:xfrm>
            <a:off x="148589" y="6164642"/>
            <a:ext cx="217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160AFC76-8EBA-C9E8-E371-0E82BAD50371}"/>
              </a:ext>
            </a:extLst>
          </p:cNvPr>
          <p:cNvSpPr txBox="1"/>
          <p:nvPr/>
        </p:nvSpPr>
        <p:spPr>
          <a:xfrm>
            <a:off x="1070712" y="8325907"/>
            <a:ext cx="217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</p:spTree>
    <p:extLst>
      <p:ext uri="{BB962C8B-B14F-4D97-AF65-F5344CB8AC3E}">
        <p14:creationId xmlns:p14="http://schemas.microsoft.com/office/powerpoint/2010/main" val="8634234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01B30A50-12F7-4829-905A-E9EA541ABEF8}"/>
              </a:ext>
            </a:extLst>
          </p:cNvPr>
          <p:cNvSpPr txBox="1"/>
          <p:nvPr/>
        </p:nvSpPr>
        <p:spPr>
          <a:xfrm>
            <a:off x="139155" y="122283"/>
            <a:ext cx="66235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Quantitative analysis of tumor cell death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ep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1-6 and MC38 tumors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xmlns="" id="{9D14598B-6C0A-4AAC-BB28-E4A4E85ECF68}"/>
              </a:ext>
            </a:extLst>
          </p:cNvPr>
          <p:cNvGrpSpPr/>
          <p:nvPr/>
        </p:nvGrpSpPr>
        <p:grpSpPr>
          <a:xfrm>
            <a:off x="1228548" y="3623750"/>
            <a:ext cx="4400904" cy="2158482"/>
            <a:chOff x="-350877" y="3470793"/>
            <a:chExt cx="6446878" cy="2783881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CF672B1C-CEDC-435A-869B-F5FAD4903CE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-123667" y="3655459"/>
              <a:ext cx="6219668" cy="2599215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xmlns="" id="{CA0975B9-27F0-4FE2-BAE2-77190C091AC4}"/>
                </a:ext>
              </a:extLst>
            </p:cNvPr>
            <p:cNvSpPr txBox="1"/>
            <p:nvPr/>
          </p:nvSpPr>
          <p:spPr>
            <a:xfrm>
              <a:off x="-350877" y="3531634"/>
              <a:ext cx="4516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DB7EAB29-833E-4BC9-9318-7B9EB06AC2EB}"/>
                </a:ext>
              </a:extLst>
            </p:cNvPr>
            <p:cNvSpPr txBox="1"/>
            <p:nvPr/>
          </p:nvSpPr>
          <p:spPr>
            <a:xfrm>
              <a:off x="2872562" y="3470793"/>
              <a:ext cx="4516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E4122EBC-8919-44DF-ABB1-2FD32744756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83711" y="642874"/>
            <a:ext cx="2136213" cy="292031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0885AD8B-5666-4553-ABD5-7D06ECAA389F}"/>
              </a:ext>
            </a:extLst>
          </p:cNvPr>
          <p:cNvSpPr txBox="1"/>
          <p:nvPr/>
        </p:nvSpPr>
        <p:spPr>
          <a:xfrm>
            <a:off x="1857879" y="703436"/>
            <a:ext cx="451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xmlns="" id="{9A71C876-16D4-E94C-8D28-6E1DF33744C8}"/>
              </a:ext>
            </a:extLst>
          </p:cNvPr>
          <p:cNvGrpSpPr/>
          <p:nvPr/>
        </p:nvGrpSpPr>
        <p:grpSpPr>
          <a:xfrm>
            <a:off x="942172" y="6135202"/>
            <a:ext cx="5133820" cy="3518119"/>
            <a:chOff x="862090" y="6295590"/>
            <a:chExt cx="5133820" cy="3518119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5B222812-7392-ED95-6F7E-E8D2F8F0DADE}"/>
                </a:ext>
              </a:extLst>
            </p:cNvPr>
            <p:cNvSpPr txBox="1"/>
            <p:nvPr/>
          </p:nvSpPr>
          <p:spPr>
            <a:xfrm>
              <a:off x="862090" y="6738890"/>
              <a:ext cx="2173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xmlns="" id="{F72A045E-575A-C0C8-A37F-034D6576D78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147840" y="6295590"/>
              <a:ext cx="4848070" cy="351811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0572152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F4A6810F-80EA-4B0F-93D4-C45078251EB7}"/>
              </a:ext>
            </a:extLst>
          </p:cNvPr>
          <p:cNvSpPr txBox="1"/>
          <p:nvPr/>
        </p:nvSpPr>
        <p:spPr>
          <a:xfrm>
            <a:off x="106680" y="124874"/>
            <a:ext cx="67513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 Immunophenotyping of tumor-infiltrating immune cells following IT administration of MMR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xmlns="" id="{1B31D87B-335F-E054-448B-CEABE4150364}"/>
              </a:ext>
            </a:extLst>
          </p:cNvPr>
          <p:cNvGrpSpPr/>
          <p:nvPr/>
        </p:nvGrpSpPr>
        <p:grpSpPr>
          <a:xfrm>
            <a:off x="-39782" y="486069"/>
            <a:ext cx="6937564" cy="9060863"/>
            <a:chOff x="0" y="486069"/>
            <a:chExt cx="6937564" cy="9060863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xmlns="" id="{D321EDCA-9FEE-0895-9A70-C1161C3918E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6713" r="5614"/>
            <a:stretch/>
          </p:blipFill>
          <p:spPr>
            <a:xfrm>
              <a:off x="341567" y="7150008"/>
              <a:ext cx="6174866" cy="2396924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7576D3B8-A32C-AD90-9B19-3527690B32E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486069"/>
              <a:ext cx="6858000" cy="4451072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04BE6A8C-ACBA-46B1-AC7A-257E85A2C89F}"/>
                </a:ext>
              </a:extLst>
            </p:cNvPr>
            <p:cNvSpPr txBox="1"/>
            <p:nvPr/>
          </p:nvSpPr>
          <p:spPr>
            <a:xfrm>
              <a:off x="184300" y="564228"/>
              <a:ext cx="45166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F6CA227D-CADF-4595-B7B6-F295803A3483}"/>
                </a:ext>
              </a:extLst>
            </p:cNvPr>
            <p:cNvSpPr txBox="1"/>
            <p:nvPr/>
          </p:nvSpPr>
          <p:spPr>
            <a:xfrm>
              <a:off x="1754282" y="584535"/>
              <a:ext cx="45166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BE6472E1-3A7B-43AE-AC81-14973A3BBCD6}"/>
                </a:ext>
              </a:extLst>
            </p:cNvPr>
            <p:cNvSpPr txBox="1"/>
            <p:nvPr/>
          </p:nvSpPr>
          <p:spPr>
            <a:xfrm>
              <a:off x="3508564" y="564228"/>
              <a:ext cx="45166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839A850A-BC63-437C-8824-5435B02AAAB3}"/>
                </a:ext>
              </a:extLst>
            </p:cNvPr>
            <p:cNvSpPr txBox="1"/>
            <p:nvPr/>
          </p:nvSpPr>
          <p:spPr>
            <a:xfrm>
              <a:off x="5155216" y="584535"/>
              <a:ext cx="45166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1A3E60A6-FA44-4C76-8825-C4A1765FD3E5}"/>
                </a:ext>
              </a:extLst>
            </p:cNvPr>
            <p:cNvSpPr txBox="1"/>
            <p:nvPr/>
          </p:nvSpPr>
          <p:spPr>
            <a:xfrm>
              <a:off x="147681" y="2915199"/>
              <a:ext cx="45166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xmlns="" id="{FFDE386E-AFC0-4695-9669-09EB2594C4AA}"/>
                </a:ext>
              </a:extLst>
            </p:cNvPr>
            <p:cNvSpPr txBox="1"/>
            <p:nvPr/>
          </p:nvSpPr>
          <p:spPr>
            <a:xfrm>
              <a:off x="1826514" y="2915199"/>
              <a:ext cx="45166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xmlns="" id="{DCBD6D96-A691-4D6A-8FA0-ACACBF964659}"/>
                </a:ext>
              </a:extLst>
            </p:cNvPr>
            <p:cNvSpPr txBox="1"/>
            <p:nvPr/>
          </p:nvSpPr>
          <p:spPr>
            <a:xfrm>
              <a:off x="3466057" y="2910175"/>
              <a:ext cx="45166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96E313CA-8CC6-489B-BCAD-61B8B16F20BA}"/>
                </a:ext>
              </a:extLst>
            </p:cNvPr>
            <p:cNvSpPr txBox="1"/>
            <p:nvPr/>
          </p:nvSpPr>
          <p:spPr>
            <a:xfrm>
              <a:off x="5162028" y="2910175"/>
              <a:ext cx="45166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xmlns="" id="{5D4128AA-857D-4341-958E-0372C6323FF6}"/>
                </a:ext>
              </a:extLst>
            </p:cNvPr>
            <p:cNvSpPr txBox="1"/>
            <p:nvPr/>
          </p:nvSpPr>
          <p:spPr>
            <a:xfrm>
              <a:off x="196042" y="4953000"/>
              <a:ext cx="45166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xmlns="" id="{66062CE4-4304-44F7-89C7-2239FAE3A550}"/>
                </a:ext>
              </a:extLst>
            </p:cNvPr>
            <p:cNvSpPr txBox="1"/>
            <p:nvPr/>
          </p:nvSpPr>
          <p:spPr>
            <a:xfrm>
              <a:off x="1792280" y="4953000"/>
              <a:ext cx="45166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xmlns="" id="{2C476469-E4B3-4A88-AE0B-EE1163AB042F}"/>
                </a:ext>
              </a:extLst>
            </p:cNvPr>
            <p:cNvSpPr txBox="1"/>
            <p:nvPr/>
          </p:nvSpPr>
          <p:spPr>
            <a:xfrm>
              <a:off x="3508564" y="4956274"/>
              <a:ext cx="45166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xmlns="" id="{49002430-3F6D-42AE-94DE-151AC902942A}"/>
                </a:ext>
              </a:extLst>
            </p:cNvPr>
            <p:cNvSpPr txBox="1"/>
            <p:nvPr/>
          </p:nvSpPr>
          <p:spPr>
            <a:xfrm>
              <a:off x="5183282" y="4953000"/>
              <a:ext cx="45166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xmlns="" id="{DE36B40C-7EC9-4BF9-9DF9-D753C7C8CD08}"/>
                </a:ext>
              </a:extLst>
            </p:cNvPr>
            <p:cNvSpPr txBox="1"/>
            <p:nvPr/>
          </p:nvSpPr>
          <p:spPr>
            <a:xfrm>
              <a:off x="402359" y="7172745"/>
              <a:ext cx="45166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xmlns="" id="{4103E244-B07A-4533-BB06-79DEBF7F6EC9}"/>
                </a:ext>
              </a:extLst>
            </p:cNvPr>
            <p:cNvSpPr txBox="1"/>
            <p:nvPr/>
          </p:nvSpPr>
          <p:spPr>
            <a:xfrm>
              <a:off x="2498652" y="7172745"/>
              <a:ext cx="45166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xmlns="" id="{0D32D2D4-2532-4D82-8D46-111F225CAE1D}"/>
                </a:ext>
              </a:extLst>
            </p:cNvPr>
            <p:cNvSpPr txBox="1"/>
            <p:nvPr/>
          </p:nvSpPr>
          <p:spPr>
            <a:xfrm>
              <a:off x="4594945" y="7172745"/>
              <a:ext cx="45166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xmlns="" id="{A8CAA4C9-D5AD-3001-A3D2-F8A1742D0E1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9564" y="5065232"/>
              <a:ext cx="6858000" cy="208477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7832870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0C77B2EE-FAF8-4A3E-95E8-659BB2666A20}"/>
              </a:ext>
            </a:extLst>
          </p:cNvPr>
          <p:cNvSpPr txBox="1"/>
          <p:nvPr/>
        </p:nvSpPr>
        <p:spPr>
          <a:xfrm>
            <a:off x="139700" y="264709"/>
            <a:ext cx="67183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top 30 most enriched Kyoto Encyclopedia of Genes and Genomes pathways</a:t>
            </a:r>
          </a:p>
        </p:txBody>
      </p:sp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xmlns="" id="{25C13ED8-A350-43C5-BE59-213865636BD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028" y="1206790"/>
            <a:ext cx="6543945" cy="5603585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5919883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>
            <a:extLst>
              <a:ext uri="{FF2B5EF4-FFF2-40B4-BE49-F238E27FC236}">
                <a16:creationId xmlns:a16="http://schemas.microsoft.com/office/drawing/2014/main" xmlns="" id="{7A52DDDC-9649-1560-BBBC-6A1D6EA827C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068"/>
          <a:stretch/>
        </p:blipFill>
        <p:spPr>
          <a:xfrm>
            <a:off x="0" y="683128"/>
            <a:ext cx="3591998" cy="3375907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002D872D-71DD-5B11-1DDD-948B14AD6BA8}"/>
              </a:ext>
            </a:extLst>
          </p:cNvPr>
          <p:cNvSpPr txBox="1"/>
          <p:nvPr/>
        </p:nvSpPr>
        <p:spPr>
          <a:xfrm>
            <a:off x="396240" y="108370"/>
            <a:ext cx="6019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6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Analysis of differentially expressed proteins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ep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1-6 tumors treated with PBS vs. MMR</a:t>
            </a:r>
          </a:p>
          <a:p>
            <a:pPr algn="ctr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xmlns="" id="{67B67AF9-40B9-0471-C8B5-E4983445A04A}"/>
              </a:ext>
            </a:extLst>
          </p:cNvPr>
          <p:cNvGrpSpPr/>
          <p:nvPr/>
        </p:nvGrpSpPr>
        <p:grpSpPr>
          <a:xfrm>
            <a:off x="171528" y="683128"/>
            <a:ext cx="6514944" cy="7943036"/>
            <a:chOff x="89460" y="683128"/>
            <a:chExt cx="6514944" cy="7943036"/>
          </a:xfrm>
        </p:grpSpPr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xmlns="" id="{6EF48DF8-3C4F-B154-63A6-808B88615A0C}"/>
                </a:ext>
              </a:extLst>
            </p:cNvPr>
            <p:cNvGrpSpPr/>
            <p:nvPr/>
          </p:nvGrpSpPr>
          <p:grpSpPr>
            <a:xfrm>
              <a:off x="2135505" y="4653307"/>
              <a:ext cx="2876550" cy="3972857"/>
              <a:chOff x="1813036" y="542317"/>
              <a:chExt cx="2876550" cy="3972857"/>
            </a:xfrm>
          </p:grpSpPr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xmlns="" id="{E750E5B2-02C4-8628-C832-474E920051F3}"/>
                  </a:ext>
                </a:extLst>
              </p:cNvPr>
              <p:cNvGrpSpPr/>
              <p:nvPr/>
            </p:nvGrpSpPr>
            <p:grpSpPr>
              <a:xfrm>
                <a:off x="1813036" y="542317"/>
                <a:ext cx="2876550" cy="2423580"/>
                <a:chOff x="2735011" y="780647"/>
                <a:chExt cx="3074980" cy="2702159"/>
              </a:xfrm>
            </p:grpSpPr>
            <p:pic>
              <p:nvPicPr>
                <p:cNvPr id="15" name="Picture 14" descr="Chart, scatter chart&#10;&#10;Description automatically generated">
                  <a:extLst>
                    <a:ext uri="{FF2B5EF4-FFF2-40B4-BE49-F238E27FC236}">
                      <a16:creationId xmlns:a16="http://schemas.microsoft.com/office/drawing/2014/main" xmlns="" id="{56DBC9D3-CD22-4787-5A66-C5068FB8C61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0646" b="1"/>
                <a:stretch/>
              </p:blipFill>
              <p:spPr>
                <a:xfrm>
                  <a:off x="2735011" y="1127699"/>
                  <a:ext cx="3074980" cy="2355107"/>
                </a:xfrm>
                <a:prstGeom prst="rect">
                  <a:avLst/>
                </a:prstGeom>
              </p:spPr>
            </p:pic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xmlns="" id="{0BB5356F-730B-3894-1222-2CA35413C446}"/>
                    </a:ext>
                  </a:extLst>
                </p:cNvPr>
                <p:cNvSpPr txBox="1"/>
                <p:nvPr/>
              </p:nvSpPr>
              <p:spPr>
                <a:xfrm>
                  <a:off x="3086805" y="780647"/>
                  <a:ext cx="2459517" cy="3431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Ps PBS vs. MMR</a:t>
                  </a:r>
                </a:p>
              </p:txBody>
            </p:sp>
          </p:grpSp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xmlns="" id="{9E4AC786-4F6A-4B13-C5A8-FB29E49D088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455607" y="3209561"/>
                <a:ext cx="1591408" cy="1305613"/>
              </a:xfrm>
              <a:prstGeom prst="rect">
                <a:avLst/>
              </a:prstGeom>
            </p:spPr>
          </p:pic>
        </p:grp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xmlns="" id="{26DC3F3F-E397-3193-E618-8C541C527D5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653289" y="1119181"/>
              <a:ext cx="2951115" cy="2564875"/>
            </a:xfrm>
            <a:prstGeom prst="rect">
              <a:avLst/>
            </a:prstGeom>
          </p:spPr>
        </p:pic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xmlns="" id="{4BC81AA0-31D2-C3F9-0C7E-B952258153F9}"/>
                </a:ext>
              </a:extLst>
            </p:cNvPr>
            <p:cNvSpPr txBox="1"/>
            <p:nvPr/>
          </p:nvSpPr>
          <p:spPr>
            <a:xfrm>
              <a:off x="89460" y="683128"/>
              <a:ext cx="2173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xmlns="" id="{737752AB-30DE-6AD5-5C7D-FCA38709CAFA}"/>
                </a:ext>
              </a:extLst>
            </p:cNvPr>
            <p:cNvSpPr txBox="1"/>
            <p:nvPr/>
          </p:nvSpPr>
          <p:spPr>
            <a:xfrm>
              <a:off x="3968040" y="1014086"/>
              <a:ext cx="2173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xmlns="" id="{8B2DE022-2D38-6D57-4FCB-986407543278}"/>
                </a:ext>
              </a:extLst>
            </p:cNvPr>
            <p:cNvSpPr txBox="1"/>
            <p:nvPr/>
          </p:nvSpPr>
          <p:spPr>
            <a:xfrm>
              <a:off x="2244714" y="4739966"/>
              <a:ext cx="2173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xmlns="" id="{1181A530-5496-9CE0-AEF0-28744C12279A}"/>
                </a:ext>
              </a:extLst>
            </p:cNvPr>
            <p:cNvSpPr txBox="1"/>
            <p:nvPr/>
          </p:nvSpPr>
          <p:spPr>
            <a:xfrm>
              <a:off x="2462035" y="7301501"/>
              <a:ext cx="2173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473325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67C295D8-3C8E-4B13-A795-18FA56E9FFF5}"/>
              </a:ext>
            </a:extLst>
          </p:cNvPr>
          <p:cNvSpPr txBox="1"/>
          <p:nvPr/>
        </p:nvSpPr>
        <p:spPr>
          <a:xfrm>
            <a:off x="228867" y="249681"/>
            <a:ext cx="614335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op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SigD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athways in the integrated datasets </a:t>
            </a:r>
          </a:p>
        </p:txBody>
      </p:sp>
      <p:pic>
        <p:nvPicPr>
          <p:cNvPr id="3" name="Picture 2" descr="Chart, box and whisker chart&#10;&#10;Description automatically generated">
            <a:extLst>
              <a:ext uri="{FF2B5EF4-FFF2-40B4-BE49-F238E27FC236}">
                <a16:creationId xmlns:a16="http://schemas.microsoft.com/office/drawing/2014/main" xmlns="" id="{99C7E7A1-E54A-4247-8452-D098030C5A9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1" r="27577" b="2853"/>
          <a:stretch/>
        </p:blipFill>
        <p:spPr>
          <a:xfrm>
            <a:off x="84101" y="1047750"/>
            <a:ext cx="6745325" cy="68389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48288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xmlns="" id="{EB1F4DF6-7CC4-26EA-6933-0482C16A35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8558183"/>
              </p:ext>
            </p:extLst>
          </p:nvPr>
        </p:nvGraphicFramePr>
        <p:xfrm>
          <a:off x="311150" y="747759"/>
          <a:ext cx="6388100" cy="4023489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924594">
                  <a:extLst>
                    <a:ext uri="{9D8B030D-6E8A-4147-A177-3AD203B41FA5}">
                      <a16:colId xmlns:a16="http://schemas.microsoft.com/office/drawing/2014/main" xmlns="" val="3458983167"/>
                    </a:ext>
                  </a:extLst>
                </a:gridCol>
                <a:gridCol w="1150893">
                  <a:extLst>
                    <a:ext uri="{9D8B030D-6E8A-4147-A177-3AD203B41FA5}">
                      <a16:colId xmlns:a16="http://schemas.microsoft.com/office/drawing/2014/main" xmlns="" val="2048873477"/>
                    </a:ext>
                  </a:extLst>
                </a:gridCol>
                <a:gridCol w="717692">
                  <a:extLst>
                    <a:ext uri="{9D8B030D-6E8A-4147-A177-3AD203B41FA5}">
                      <a16:colId xmlns:a16="http://schemas.microsoft.com/office/drawing/2014/main" xmlns="" val="1938685840"/>
                    </a:ext>
                  </a:extLst>
                </a:gridCol>
                <a:gridCol w="936825">
                  <a:extLst>
                    <a:ext uri="{9D8B030D-6E8A-4147-A177-3AD203B41FA5}">
                      <a16:colId xmlns:a16="http://schemas.microsoft.com/office/drawing/2014/main" xmlns="" val="2028610053"/>
                    </a:ext>
                  </a:extLst>
                </a:gridCol>
                <a:gridCol w="1779411">
                  <a:extLst>
                    <a:ext uri="{9D8B030D-6E8A-4147-A177-3AD203B41FA5}">
                      <a16:colId xmlns:a16="http://schemas.microsoft.com/office/drawing/2014/main" xmlns="" val="876633686"/>
                    </a:ext>
                  </a:extLst>
                </a:gridCol>
                <a:gridCol w="878685">
                  <a:extLst>
                    <a:ext uri="{9D8B030D-6E8A-4147-A177-3AD203B41FA5}">
                      <a16:colId xmlns:a16="http://schemas.microsoft.com/office/drawing/2014/main" xmlns="" val="1567999891"/>
                    </a:ext>
                  </a:extLst>
                </a:gridCol>
              </a:tblGrid>
              <a:tr h="41012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rkers</a:t>
                      </a:r>
                      <a:endParaRPr lang="en-US" sz="1100" b="1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uorochrome</a:t>
                      </a:r>
                      <a:endParaRPr lang="en-US" sz="1100" b="1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ne</a:t>
                      </a:r>
                      <a:endParaRPr lang="en-US" sz="1100" b="1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alog</a:t>
                      </a:r>
                      <a:endParaRPr lang="en-US" sz="1100" b="1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otypes</a:t>
                      </a:r>
                      <a:endParaRPr lang="en-US" sz="1100" b="1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nder</a:t>
                      </a:r>
                      <a:endParaRPr lang="en-US" sz="1100" b="1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254142021"/>
                  </a:ext>
                </a:extLst>
              </a:tr>
              <a:tr h="22473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</a:t>
                      </a:r>
                      <a:endParaRPr lang="en-US" sz="1100" b="1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TC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-F11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3079</a:t>
                      </a:r>
                      <a:endParaRPr lang="en-US" sz="1100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 IgG2b, κ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  <a:endParaRPr lang="en-US" sz="1100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690838547"/>
                  </a:ext>
                </a:extLst>
              </a:tr>
              <a:tr h="46705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</a:t>
                      </a:r>
                      <a:endParaRPr lang="en-US" sz="1100" b="1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V395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5-2C11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3565</a:t>
                      </a:r>
                      <a:endParaRPr lang="en-US" sz="1100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menian Hamster IgG1, κ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  <a:endParaRPr lang="en-US" sz="1100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809884316"/>
                  </a:ext>
                </a:extLst>
              </a:tr>
              <a:tr h="22473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</a:t>
                      </a:r>
                      <a:endParaRPr lang="en-US" sz="1100" b="1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V737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K1.5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2761</a:t>
                      </a:r>
                      <a:endParaRPr lang="en-US" sz="1100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 IgG2b, κ 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905796822"/>
                  </a:ext>
                </a:extLst>
              </a:tr>
              <a:tr h="22473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</a:t>
                      </a:r>
                      <a:endParaRPr lang="en-US" sz="1100" b="1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cp-Cy5.5</a:t>
                      </a:r>
                      <a:endParaRPr lang="en-US" sz="1100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-6.7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-0081-82 </a:t>
                      </a:r>
                      <a:endParaRPr lang="en-US" sz="1100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 IgG2a, k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Bioscience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942976542"/>
                  </a:ext>
                </a:extLst>
              </a:tr>
              <a:tr h="22473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4</a:t>
                      </a:r>
                      <a:endParaRPr lang="en-US" sz="1100" b="1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V711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7 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057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 IgG2b, k</a:t>
                      </a:r>
                      <a:endParaRPr lang="en-US" sz="1100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571484834"/>
                  </a:ext>
                </a:extLst>
              </a:tr>
              <a:tr h="22473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35</a:t>
                      </a:r>
                      <a:endParaRPr lang="en-US" sz="1100" b="1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/DAzzle594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A1.4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7630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 IgG2a, κ</a:t>
                      </a:r>
                      <a:endParaRPr lang="en-US" sz="1100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418135744"/>
                  </a:ext>
                </a:extLst>
              </a:tr>
              <a:tr h="22473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1</a:t>
                      </a:r>
                      <a:endParaRPr lang="en-US" sz="1100" b="1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43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1892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menian Hamster IgG2, κ</a:t>
                      </a:r>
                      <a:endParaRPr lang="en-US" sz="1100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87718810"/>
                  </a:ext>
                </a:extLst>
              </a:tr>
              <a:tr h="22473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67*</a:t>
                      </a:r>
                      <a:endParaRPr lang="en-US" sz="1100" b="1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V605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A8 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2413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 IgG2a, κ</a:t>
                      </a:r>
                      <a:endParaRPr lang="en-US" sz="1100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4023468568"/>
                  </a:ext>
                </a:extLst>
              </a:tr>
              <a:tr h="22473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zyme B*</a:t>
                      </a:r>
                      <a:endParaRPr lang="en-US" sz="1100" b="1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A18A28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6408</a:t>
                      </a:r>
                      <a:endParaRPr lang="en-US" sz="1100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205316899"/>
                  </a:ext>
                </a:extLst>
              </a:tr>
              <a:tr h="22473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N-γ*</a:t>
                      </a:r>
                      <a:endParaRPr lang="en-US" sz="1100" b="1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V421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MG1.2 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3376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 IgG1, κ</a:t>
                      </a:r>
                      <a:endParaRPr lang="en-US" sz="1100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673224621"/>
                  </a:ext>
                </a:extLst>
              </a:tr>
              <a:tr h="22473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1b</a:t>
                      </a:r>
                      <a:endParaRPr lang="en-US" sz="1100" b="1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-Cy7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/70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216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 IgG2b, κ </a:t>
                      </a:r>
                      <a:endParaRPr lang="en-US" sz="1100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9660437"/>
                  </a:ext>
                </a:extLst>
              </a:tr>
              <a:tr h="22473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4/80</a:t>
                      </a:r>
                      <a:endParaRPr lang="en-US" sz="1100" b="1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V510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8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3135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 IgG2a, k</a:t>
                      </a:r>
                      <a:endParaRPr lang="en-US" sz="1100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628962200"/>
                  </a:ext>
                </a:extLst>
              </a:tr>
              <a:tr h="22473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06</a:t>
                      </a:r>
                      <a:endParaRPr lang="en-US" sz="1100" b="1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700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068C2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1734</a:t>
                      </a:r>
                      <a:endParaRPr lang="en-US" sz="1100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 IgG2a, κ</a:t>
                      </a:r>
                      <a:endParaRPr lang="en-US" sz="1100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US" sz="1100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380417293"/>
                  </a:ext>
                </a:extLst>
              </a:tr>
              <a:tr h="22473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-A/I-E</a:t>
                      </a:r>
                      <a:endParaRPr lang="en-US" sz="1100" b="1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V786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G9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3875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 IgG2a, κ</a:t>
                      </a:r>
                      <a:endParaRPr lang="en-US" sz="1100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  <a:endParaRPr lang="en-US" sz="1100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837692712"/>
                  </a:ext>
                </a:extLst>
              </a:tr>
              <a:tr h="22473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/D </a:t>
                      </a:r>
                      <a:endParaRPr lang="en-US" sz="1100" b="1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fluo780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-0865-18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110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Bioscience</a:t>
                      </a:r>
                      <a:endParaRPr lang="en-US" sz="1100" dirty="0">
                        <a:solidFill>
                          <a:srgbClr val="797979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0221" marR="602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086638192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A9ED2D3D-FA38-E738-8744-77C5A2BD0A64}"/>
              </a:ext>
            </a:extLst>
          </p:cNvPr>
          <p:cNvSpPr txBox="1"/>
          <p:nvPr/>
        </p:nvSpPr>
        <p:spPr>
          <a:xfrm>
            <a:off x="0" y="182024"/>
            <a:ext cx="67513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ist of antibodies used in the flow cytometry analysi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A06D7830-FCD7-4F14-0A1A-0792191C7B62}"/>
              </a:ext>
            </a:extLst>
          </p:cNvPr>
          <p:cNvSpPr txBox="1"/>
          <p:nvPr/>
        </p:nvSpPr>
        <p:spPr>
          <a:xfrm>
            <a:off x="311150" y="4875318"/>
            <a:ext cx="43434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 Ki67, Granzyme B and </a:t>
            </a:r>
            <a:r>
              <a:rPr lang="en-US" sz="11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IFN-γ*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re the intracellular targets</a:t>
            </a:r>
            <a:r>
              <a:rPr lang="en-US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9842054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56</TotalTime>
  <Words>487</Words>
  <Application>Microsoft Office PowerPoint</Application>
  <PresentationFormat>A4 Paper (210x297 mm)</PresentationFormat>
  <Paragraphs>197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Supplementary dat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galo, Bolni M</dc:creator>
  <cp:lastModifiedBy>Tino</cp:lastModifiedBy>
  <cp:revision>15</cp:revision>
  <cp:lastPrinted>2022-07-20T17:09:03Z</cp:lastPrinted>
  <dcterms:created xsi:type="dcterms:W3CDTF">2022-03-18T13:37:24Z</dcterms:created>
  <dcterms:modified xsi:type="dcterms:W3CDTF">2022-11-04T09:10:03Z</dcterms:modified>
</cp:coreProperties>
</file>